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352" r:id="rId2"/>
    <p:sldId id="357" r:id="rId3"/>
    <p:sldId id="358" r:id="rId4"/>
  </p:sldIdLst>
  <p:sldSz cx="9144000" cy="6858000" type="screen4x3"/>
  <p:notesSz cx="9866313" cy="673576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6" userDrawn="1">
          <p15:clr>
            <a:srgbClr val="A4A3A4"/>
          </p15:clr>
        </p15:guide>
        <p15:guide id="2" pos="210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123" autoAdjust="0"/>
    <p:restoredTop sz="94660"/>
  </p:normalViewPr>
  <p:slideViewPr>
    <p:cSldViewPr snapToGrid="0">
      <p:cViewPr varScale="1">
        <p:scale>
          <a:sx n="87" d="100"/>
          <a:sy n="87" d="100"/>
        </p:scale>
        <p:origin x="1308" y="90"/>
      </p:cViewPr>
      <p:guideLst>
        <p:guide orient="horz" pos="1706"/>
        <p:guide pos="210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264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_Workshee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20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2000" b="1"/>
              <a:t>Gait speed (m/sec)</a:t>
            </a:r>
            <a:endParaRPr lang="ja-JP" sz="2000" b="1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20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601168636766704"/>
          <c:y val="0.19217616580310881"/>
          <c:w val="0.85847261655860263"/>
          <c:h val="0.68309126514626073"/>
        </c:manualLayout>
      </c:layout>
      <c:barChart>
        <c:barDir val="col"/>
        <c:grouping val="clustered"/>
        <c:varyColors val="0"/>
        <c:ser>
          <c:idx val="0"/>
          <c:order val="0"/>
          <c:tx>
            <c:v>Before</c:v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val>
            <c:numRef>
              <c:f>Sheet1!$C$7:$C$16</c:f>
              <c:numCache>
                <c:formatCode>0.00_ </c:formatCode>
                <c:ptCount val="10"/>
                <c:pt idx="0">
                  <c:v>1.098901098901099</c:v>
                </c:pt>
                <c:pt idx="1">
                  <c:v>1.0131712259371835</c:v>
                </c:pt>
                <c:pt idx="2">
                  <c:v>1.0845986984815617</c:v>
                </c:pt>
                <c:pt idx="3">
                  <c:v>1.1363636363636362</c:v>
                </c:pt>
                <c:pt idx="4">
                  <c:v>1.0976948408342482</c:v>
                </c:pt>
                <c:pt idx="5">
                  <c:v>1.1261261261261259</c:v>
                </c:pt>
                <c:pt idx="6">
                  <c:v>1.098901098901099</c:v>
                </c:pt>
                <c:pt idx="7">
                  <c:v>1.1325028312570782</c:v>
                </c:pt>
                <c:pt idx="8">
                  <c:v>1.1325028312570782</c:v>
                </c:pt>
                <c:pt idx="9">
                  <c:v>1.144164759725400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76C8-423D-BEBE-5FAC22848A74}"/>
            </c:ext>
          </c:extLst>
        </c:ser>
        <c:ser>
          <c:idx val="1"/>
          <c:order val="1"/>
          <c:tx>
            <c:v>After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Sheet1!$D$7:$D$16</c:f>
              <c:numCache>
                <c:formatCode>0.00_ </c:formatCode>
                <c:ptCount val="10"/>
                <c:pt idx="0">
                  <c:v>1.0111223458038423</c:v>
                </c:pt>
                <c:pt idx="1">
                  <c:v>1.0504201680672269</c:v>
                </c:pt>
                <c:pt idx="2">
                  <c:v>1.1037527593818983</c:v>
                </c:pt>
                <c:pt idx="3">
                  <c:v>1.1363636363636362</c:v>
                </c:pt>
                <c:pt idx="4">
                  <c:v>1.1363636363636362</c:v>
                </c:pt>
                <c:pt idx="5">
                  <c:v>1.122334455667789</c:v>
                </c:pt>
                <c:pt idx="6">
                  <c:v>1.1402508551881414</c:v>
                </c:pt>
                <c:pt idx="7">
                  <c:v>1.1904761904761905</c:v>
                </c:pt>
                <c:pt idx="8">
                  <c:v>1.1013215859030836</c:v>
                </c:pt>
                <c:pt idx="9">
                  <c:v>1.16009280742459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76C8-423D-BEBE-5FAC22848A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838373904"/>
        <c:axId val="-1838364112"/>
      </c:barChart>
      <c:catAx>
        <c:axId val="-1838373904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38364112"/>
        <c:crosses val="autoZero"/>
        <c:auto val="1"/>
        <c:lblAlgn val="ctr"/>
        <c:lblOffset val="100"/>
        <c:noMultiLvlLbl val="0"/>
      </c:catAx>
      <c:valAx>
        <c:axId val="-183836411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3837390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1412350208670614"/>
          <c:y val="0.12499938802986414"/>
          <c:w val="0.16759838954443498"/>
          <c:h val="0.144430663783607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>
          <a:solidFill>
            <a:schemeClr val="tx1"/>
          </a:solidFill>
        </a:defRPr>
      </a:pPr>
      <a:endParaRPr lang="en-US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20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altLang="ja-JP" sz="2000" b="1" dirty="0">
                <a:solidFill>
                  <a:schemeClr val="tx1"/>
                </a:solidFill>
              </a:rPr>
              <a:t>Step length (m)</a:t>
            </a:r>
            <a:endParaRPr lang="ja-JP" altLang="en-US" sz="2000" b="1" dirty="0">
              <a:solidFill>
                <a:schemeClr val="tx1"/>
              </a:solidFill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20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601168636766704"/>
          <c:y val="0.19217616580310881"/>
          <c:w val="0.85847261655860263"/>
          <c:h val="0.68309126514626073"/>
        </c:manualLayout>
      </c:layout>
      <c:barChart>
        <c:barDir val="col"/>
        <c:grouping val="clustered"/>
        <c:varyColors val="0"/>
        <c:ser>
          <c:idx val="0"/>
          <c:order val="0"/>
          <c:tx>
            <c:v>Before</c:v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val>
            <c:numRef>
              <c:f>Sheet1!$E$7:$E$16</c:f>
              <c:numCache>
                <c:formatCode>0.00_ </c:formatCode>
                <c:ptCount val="10"/>
                <c:pt idx="0">
                  <c:v>0.55555555555555558</c:v>
                </c:pt>
                <c:pt idx="1">
                  <c:v>0.52631578947368418</c:v>
                </c:pt>
                <c:pt idx="2">
                  <c:v>0.55555555555555558</c:v>
                </c:pt>
                <c:pt idx="3">
                  <c:v>0.58823529411764708</c:v>
                </c:pt>
                <c:pt idx="4">
                  <c:v>0.5714285714285714</c:v>
                </c:pt>
                <c:pt idx="5">
                  <c:v>0.5714285714285714</c:v>
                </c:pt>
                <c:pt idx="6">
                  <c:v>0.58823529411764708</c:v>
                </c:pt>
                <c:pt idx="7">
                  <c:v>0.58823529411764708</c:v>
                </c:pt>
                <c:pt idx="8">
                  <c:v>0.5714285714285714</c:v>
                </c:pt>
                <c:pt idx="9">
                  <c:v>0.588235294117647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FBD-48BB-9455-B3A258C705DD}"/>
            </c:ext>
          </c:extLst>
        </c:ser>
        <c:ser>
          <c:idx val="1"/>
          <c:order val="1"/>
          <c:tx>
            <c:v>After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Sheet1!$F$7:$F$16</c:f>
              <c:numCache>
                <c:formatCode>0.00_ </c:formatCode>
                <c:ptCount val="10"/>
                <c:pt idx="0">
                  <c:v>0.55555555555555558</c:v>
                </c:pt>
                <c:pt idx="1">
                  <c:v>0.55555555555555558</c:v>
                </c:pt>
                <c:pt idx="2">
                  <c:v>0.58823529411764708</c:v>
                </c:pt>
                <c:pt idx="3">
                  <c:v>0.625</c:v>
                </c:pt>
                <c:pt idx="4">
                  <c:v>0.60606060606060608</c:v>
                </c:pt>
                <c:pt idx="5">
                  <c:v>0.60606060606060608</c:v>
                </c:pt>
                <c:pt idx="6">
                  <c:v>0.60606060606060608</c:v>
                </c:pt>
                <c:pt idx="7">
                  <c:v>0.625</c:v>
                </c:pt>
                <c:pt idx="8">
                  <c:v>0.58823529411764708</c:v>
                </c:pt>
                <c:pt idx="9">
                  <c:v>0.606060606060606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3FBD-48BB-9455-B3A258C705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838374448"/>
        <c:axId val="-1838372272"/>
      </c:barChart>
      <c:catAx>
        <c:axId val="-183837444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38372272"/>
        <c:crosses val="autoZero"/>
        <c:auto val="1"/>
        <c:lblAlgn val="ctr"/>
        <c:lblOffset val="100"/>
        <c:noMultiLvlLbl val="0"/>
      </c:catAx>
      <c:valAx>
        <c:axId val="-1838372272"/>
        <c:scaling>
          <c:orientation val="minMax"/>
          <c:min val="0.5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383744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1412350208670614"/>
          <c:y val="0.12499938802986414"/>
          <c:w val="0.15309807722032848"/>
          <c:h val="0.144430663783607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800" b="1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lang="ja-JP" sz="20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 sz="2000"/>
              <a:t>Cadence (steps/min)</a:t>
            </a:r>
            <a:endParaRPr lang="ja-JP" sz="200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20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0601168636766704"/>
          <c:y val="0.19217616580310881"/>
          <c:w val="0.85847261655860263"/>
          <c:h val="0.68309126514626073"/>
        </c:manualLayout>
      </c:layout>
      <c:barChart>
        <c:barDir val="col"/>
        <c:grouping val="clustered"/>
        <c:varyColors val="0"/>
        <c:ser>
          <c:idx val="0"/>
          <c:order val="0"/>
          <c:tx>
            <c:v>Before</c:v>
          </c:tx>
          <c:spPr>
            <a:solidFill>
              <a:srgbClr val="00B0F0"/>
            </a:solidFill>
            <a:ln>
              <a:noFill/>
            </a:ln>
            <a:effectLst/>
          </c:spPr>
          <c:invertIfNegative val="0"/>
          <c:val>
            <c:numRef>
              <c:f>Sheet1!$G$7:$G$16</c:f>
              <c:numCache>
                <c:formatCode>0.0_ </c:formatCode>
                <c:ptCount val="10"/>
                <c:pt idx="0">
                  <c:v>118.68131868131869</c:v>
                </c:pt>
                <c:pt idx="1">
                  <c:v>115.50151975683892</c:v>
                </c:pt>
                <c:pt idx="2">
                  <c:v>117.13665943600867</c:v>
                </c:pt>
                <c:pt idx="3">
                  <c:v>115.90909090909091</c:v>
                </c:pt>
                <c:pt idx="4">
                  <c:v>115.25795828759605</c:v>
                </c:pt>
                <c:pt idx="5">
                  <c:v>118.24324324324323</c:v>
                </c:pt>
                <c:pt idx="6">
                  <c:v>112.08791208791209</c:v>
                </c:pt>
                <c:pt idx="7">
                  <c:v>115.51528878822197</c:v>
                </c:pt>
                <c:pt idx="8">
                  <c:v>118.91279728199319</c:v>
                </c:pt>
                <c:pt idx="9">
                  <c:v>116.7048054919908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6F4-4905-ABB5-106E5089F5FA}"/>
            </c:ext>
          </c:extLst>
        </c:ser>
        <c:ser>
          <c:idx val="1"/>
          <c:order val="1"/>
          <c:tx>
            <c:v>After</c:v>
          </c:tx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val>
            <c:numRef>
              <c:f>Sheet1!$H$7:$H$16</c:f>
              <c:numCache>
                <c:formatCode>0.0_ </c:formatCode>
                <c:ptCount val="10"/>
                <c:pt idx="0">
                  <c:v>109.20121334681495</c:v>
                </c:pt>
                <c:pt idx="1">
                  <c:v>113.44537815126051</c:v>
                </c:pt>
                <c:pt idx="2">
                  <c:v>112.58278145695363</c:v>
                </c:pt>
                <c:pt idx="3">
                  <c:v>109.09090909090909</c:v>
                </c:pt>
                <c:pt idx="4">
                  <c:v>112.49999999999999</c:v>
                </c:pt>
                <c:pt idx="5">
                  <c:v>111.11111111111111</c:v>
                </c:pt>
                <c:pt idx="6">
                  <c:v>112.88483466362599</c:v>
                </c:pt>
                <c:pt idx="7">
                  <c:v>114.28571428571428</c:v>
                </c:pt>
                <c:pt idx="8">
                  <c:v>112.33480176211454</c:v>
                </c:pt>
                <c:pt idx="9">
                  <c:v>114.8491879350348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6F4-4905-ABB5-106E5089F5F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838371728"/>
        <c:axId val="-1838371184"/>
      </c:barChart>
      <c:catAx>
        <c:axId val="-1838371728"/>
        <c:scaling>
          <c:orientation val="minMax"/>
        </c:scaling>
        <c:delete val="0"/>
        <c:axPos val="b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38371184"/>
        <c:crosses val="autoZero"/>
        <c:auto val="1"/>
        <c:lblAlgn val="ctr"/>
        <c:lblOffset val="100"/>
        <c:noMultiLvlLbl val="0"/>
      </c:catAx>
      <c:valAx>
        <c:axId val="-1838371184"/>
        <c:scaling>
          <c:orientation val="minMax"/>
          <c:max val="120"/>
          <c:min val="1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.0_ 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2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-18383717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8099615197061576"/>
          <c:y val="6.4069058127021031E-2"/>
          <c:w val="0.15309807722032848"/>
          <c:h val="0.1444306637836073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ja-JP" sz="18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275402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588628" y="0"/>
            <a:ext cx="4275402" cy="33795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43214F-AADE-4747-8049-1A720323CC90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417888" y="841375"/>
            <a:ext cx="3030537" cy="22733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86632" y="3241586"/>
            <a:ext cx="7893050" cy="265220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397806"/>
            <a:ext cx="4275402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588628" y="6397806"/>
            <a:ext cx="4275402" cy="33795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0C6CD6-1BF5-DF41-B524-BD5B5C6DE21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5274727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09053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255858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4040946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477084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485102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66749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80329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690720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075538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63706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dirty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9701535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6F70AE-25DE-43BA-87A3-25DC622AAD59}" type="datetimeFigureOut">
              <a:rPr kumimoji="1" lang="ja-JP" altLang="en-US" smtClean="0"/>
              <a:t>2022/2/23</a:t>
            </a:fld>
            <a:endParaRPr kumimoji="1" lang="ja-JP" alt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8076D1-FFB2-45E2-BD59-F15423A03E2F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99383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グループ化 16">
            <a:extLst>
              <a:ext uri="{FF2B5EF4-FFF2-40B4-BE49-F238E27FC236}">
                <a16:creationId xmlns:a16="http://schemas.microsoft.com/office/drawing/2014/main" xmlns="" id="{9012B290-3FE0-4E7F-8BBB-A7A021E68DCA}"/>
              </a:ext>
            </a:extLst>
          </p:cNvPr>
          <p:cNvGrpSpPr/>
          <p:nvPr/>
        </p:nvGrpSpPr>
        <p:grpSpPr>
          <a:xfrm>
            <a:off x="1368543" y="1284583"/>
            <a:ext cx="6130936" cy="3997368"/>
            <a:chOff x="982040" y="879229"/>
            <a:chExt cx="6130936" cy="3997368"/>
          </a:xfrm>
        </p:grpSpPr>
        <p:graphicFrame>
          <p:nvGraphicFramePr>
            <p:cNvPr id="4" name="グラフ 3">
              <a:extLst>
                <a:ext uri="{FF2B5EF4-FFF2-40B4-BE49-F238E27FC236}">
                  <a16:creationId xmlns:a16="http://schemas.microsoft.com/office/drawing/2014/main" xmlns="" id="{51AD0BB1-6BA8-42B6-BC01-451B05F9C4B4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3477569"/>
                </p:ext>
              </p:extLst>
            </p:nvPr>
          </p:nvGraphicFramePr>
          <p:xfrm>
            <a:off x="982040" y="879229"/>
            <a:ext cx="6130936" cy="399736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6" name="直線コネクタ 5">
              <a:extLst>
                <a:ext uri="{FF2B5EF4-FFF2-40B4-BE49-F238E27FC236}">
                  <a16:creationId xmlns:a16="http://schemas.microsoft.com/office/drawing/2014/main" xmlns="" id="{8E80FB7C-1DE8-4DEF-B956-BA650A8F56F0}"/>
                </a:ext>
              </a:extLst>
            </p:cNvPr>
            <p:cNvCxnSpPr/>
            <p:nvPr/>
          </p:nvCxnSpPr>
          <p:spPr>
            <a:xfrm>
              <a:off x="1644166" y="4369774"/>
              <a:ext cx="524021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線コネクタ 7">
              <a:extLst>
                <a:ext uri="{FF2B5EF4-FFF2-40B4-BE49-F238E27FC236}">
                  <a16:creationId xmlns:a16="http://schemas.microsoft.com/office/drawing/2014/main" xmlns="" id="{0D994156-E868-4F31-96C2-6DE5ED773655}"/>
                </a:ext>
              </a:extLst>
            </p:cNvPr>
            <p:cNvCxnSpPr>
              <a:cxnSpLocks/>
            </p:cNvCxnSpPr>
            <p:nvPr/>
          </p:nvCxnSpPr>
          <p:spPr>
            <a:xfrm>
              <a:off x="1556240" y="1477105"/>
              <a:ext cx="0" cy="28926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xmlns="" id="{800B4FC0-2FAD-4108-A2F1-1E8CA0AE2BD9}"/>
                </a:ext>
              </a:extLst>
            </p:cNvPr>
            <p:cNvSpPr/>
            <p:nvPr/>
          </p:nvSpPr>
          <p:spPr>
            <a:xfrm>
              <a:off x="1134211" y="4264267"/>
              <a:ext cx="395650" cy="2285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xmlns="" id="{3B1D304F-145E-40B4-A4F3-CE77C794DD79}"/>
                </a:ext>
              </a:extLst>
            </p:cNvPr>
            <p:cNvGrpSpPr/>
            <p:nvPr/>
          </p:nvGrpSpPr>
          <p:grpSpPr>
            <a:xfrm rot="5400000">
              <a:off x="1500284" y="4131885"/>
              <a:ext cx="96718" cy="203219"/>
              <a:chOff x="5402012" y="1314145"/>
              <a:chExt cx="261761" cy="801983"/>
            </a:xfrm>
          </p:grpSpPr>
          <p:sp>
            <p:nvSpPr>
              <p:cNvPr id="12" name="フリーフォーム 76">
                <a:extLst>
                  <a:ext uri="{FF2B5EF4-FFF2-40B4-BE49-F238E27FC236}">
                    <a16:creationId xmlns:a16="http://schemas.microsoft.com/office/drawing/2014/main" xmlns="" id="{540D3234-6F1D-45F9-878C-325E17FAFAE8}"/>
                  </a:ext>
                </a:extLst>
              </p:cNvPr>
              <p:cNvSpPr/>
              <p:nvPr/>
            </p:nvSpPr>
            <p:spPr>
              <a:xfrm rot="16200000">
                <a:off x="5061143" y="1665897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13" name="フリーフォーム 77">
                <a:extLst>
                  <a:ext uri="{FF2B5EF4-FFF2-40B4-BE49-F238E27FC236}">
                    <a16:creationId xmlns:a16="http://schemas.microsoft.com/office/drawing/2014/main" xmlns="" id="{5FA656D3-DE0D-4891-A785-E73828D64522}"/>
                  </a:ext>
                </a:extLst>
              </p:cNvPr>
              <p:cNvSpPr/>
              <p:nvPr/>
            </p:nvSpPr>
            <p:spPr>
              <a:xfrm rot="16200000">
                <a:off x="5213543" y="1655014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</p:grpSp>
      <p:sp>
        <p:nvSpPr>
          <p:cNvPr id="16" name="Rectangle 41">
            <a:extLst>
              <a:ext uri="{FF2B5EF4-FFF2-40B4-BE49-F238E27FC236}">
                <a16:creationId xmlns:a16="http://schemas.microsoft.com/office/drawing/2014/main" xmlns="" id="{32FAFA51-41D7-4028-A964-B41EEE0F6C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59520" y="5065541"/>
            <a:ext cx="1654264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>
                <a:solidFill>
                  <a:srgbClr val="000000"/>
                </a:solidFill>
              </a:rPr>
              <a:t>HAL</a:t>
            </a:r>
            <a:r>
              <a:rPr lang="ja-JP" altLang="en-US" b="1" dirty="0">
                <a:solidFill>
                  <a:srgbClr val="000000"/>
                </a:solidFill>
              </a:rPr>
              <a:t> </a:t>
            </a:r>
            <a:r>
              <a:rPr lang="en-US" altLang="ja-JP" b="1" dirty="0">
                <a:solidFill>
                  <a:srgbClr val="000000"/>
                </a:solidFill>
              </a:rPr>
              <a:t>session</a:t>
            </a:r>
          </a:p>
        </p:txBody>
      </p:sp>
      <p:sp>
        <p:nvSpPr>
          <p:cNvPr id="14" name="Rectangle 41">
            <a:extLst>
              <a:ext uri="{FF2B5EF4-FFF2-40B4-BE49-F238E27FC236}">
                <a16:creationId xmlns:a16="http://schemas.microsoft.com/office/drawing/2014/main" xmlns="" id="{B76C4745-E8B0-4F84-B779-F53BAE8451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2" y="6287837"/>
            <a:ext cx="2507597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6A</a:t>
            </a:r>
          </a:p>
        </p:txBody>
      </p:sp>
    </p:spTree>
    <p:extLst>
      <p:ext uri="{BB962C8B-B14F-4D97-AF65-F5344CB8AC3E}">
        <p14:creationId xmlns:p14="http://schemas.microsoft.com/office/powerpoint/2010/main" val="41532660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xmlns="" id="{ABFF83FF-FE48-4CCB-BB20-9A3C3EBD75D8}"/>
              </a:ext>
            </a:extLst>
          </p:cNvPr>
          <p:cNvGrpSpPr/>
          <p:nvPr/>
        </p:nvGrpSpPr>
        <p:grpSpPr>
          <a:xfrm>
            <a:off x="1446646" y="1258207"/>
            <a:ext cx="6066698" cy="4018091"/>
            <a:chOff x="984733" y="852854"/>
            <a:chExt cx="6066698" cy="4018091"/>
          </a:xfrm>
        </p:grpSpPr>
        <p:graphicFrame>
          <p:nvGraphicFramePr>
            <p:cNvPr id="2" name="グラフ 1">
              <a:extLst>
                <a:ext uri="{FF2B5EF4-FFF2-40B4-BE49-F238E27FC236}">
                  <a16:creationId xmlns:a16="http://schemas.microsoft.com/office/drawing/2014/main" xmlns="" id="{74F1F80E-8E81-4AD3-A100-ABD2D7C2F54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88270187"/>
                </p:ext>
              </p:extLst>
            </p:nvPr>
          </p:nvGraphicFramePr>
          <p:xfrm>
            <a:off x="984733" y="852854"/>
            <a:ext cx="6066698" cy="40180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xmlns="" id="{9C685434-2B4E-4593-B246-6ADCCA520121}"/>
                </a:ext>
              </a:extLst>
            </p:cNvPr>
            <p:cNvCxnSpPr/>
            <p:nvPr/>
          </p:nvCxnSpPr>
          <p:spPr>
            <a:xfrm>
              <a:off x="1644166" y="4369774"/>
              <a:ext cx="524021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xmlns="" id="{37826FEF-0503-4481-8BBE-55DDEFEB945F}"/>
                </a:ext>
              </a:extLst>
            </p:cNvPr>
            <p:cNvCxnSpPr>
              <a:cxnSpLocks/>
            </p:cNvCxnSpPr>
            <p:nvPr/>
          </p:nvCxnSpPr>
          <p:spPr>
            <a:xfrm>
              <a:off x="1556240" y="1477105"/>
              <a:ext cx="0" cy="28926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xmlns="" id="{37610DD1-FF43-48CC-BB80-E62503F72BF6}"/>
                </a:ext>
              </a:extLst>
            </p:cNvPr>
            <p:cNvGrpSpPr/>
            <p:nvPr/>
          </p:nvGrpSpPr>
          <p:grpSpPr>
            <a:xfrm rot="5400000">
              <a:off x="1500284" y="4131885"/>
              <a:ext cx="96718" cy="203219"/>
              <a:chOff x="5402012" y="1314145"/>
              <a:chExt cx="261761" cy="801983"/>
            </a:xfrm>
          </p:grpSpPr>
          <p:sp>
            <p:nvSpPr>
              <p:cNvPr id="6" name="フリーフォーム 76">
                <a:extLst>
                  <a:ext uri="{FF2B5EF4-FFF2-40B4-BE49-F238E27FC236}">
                    <a16:creationId xmlns:a16="http://schemas.microsoft.com/office/drawing/2014/main" xmlns="" id="{ED868DCB-10C8-49B9-9E94-DECBB5B36BDF}"/>
                  </a:ext>
                </a:extLst>
              </p:cNvPr>
              <p:cNvSpPr/>
              <p:nvPr/>
            </p:nvSpPr>
            <p:spPr>
              <a:xfrm rot="16200000">
                <a:off x="5061143" y="1665897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" name="フリーフォーム 77">
                <a:extLst>
                  <a:ext uri="{FF2B5EF4-FFF2-40B4-BE49-F238E27FC236}">
                    <a16:creationId xmlns:a16="http://schemas.microsoft.com/office/drawing/2014/main" xmlns="" id="{149BD697-F9AD-45F0-803B-C22F8983578E}"/>
                  </a:ext>
                </a:extLst>
              </p:cNvPr>
              <p:cNvSpPr/>
              <p:nvPr/>
            </p:nvSpPr>
            <p:spPr>
              <a:xfrm rot="16200000">
                <a:off x="5213543" y="1655014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xmlns="" id="{D1490572-6088-471C-9DCB-F2E15537C3E8}"/>
                </a:ext>
              </a:extLst>
            </p:cNvPr>
            <p:cNvSpPr/>
            <p:nvPr/>
          </p:nvSpPr>
          <p:spPr>
            <a:xfrm>
              <a:off x="1122922" y="4286845"/>
              <a:ext cx="395650" cy="22859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1" name="Rectangle 41">
            <a:extLst>
              <a:ext uri="{FF2B5EF4-FFF2-40B4-BE49-F238E27FC236}">
                <a16:creationId xmlns:a16="http://schemas.microsoft.com/office/drawing/2014/main" xmlns="" id="{39EB2D41-A4D8-4C8C-A389-925FFF7E5C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034930" y="5065540"/>
            <a:ext cx="1654264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>
                <a:solidFill>
                  <a:srgbClr val="000000"/>
                </a:solidFill>
              </a:rPr>
              <a:t>HAL</a:t>
            </a:r>
            <a:r>
              <a:rPr lang="ja-JP" altLang="en-US" b="1" dirty="0">
                <a:solidFill>
                  <a:srgbClr val="000000"/>
                </a:solidFill>
              </a:rPr>
              <a:t> </a:t>
            </a:r>
            <a:r>
              <a:rPr lang="en-US" altLang="ja-JP" b="1" dirty="0">
                <a:solidFill>
                  <a:srgbClr val="000000"/>
                </a:solidFill>
              </a:rPr>
              <a:t>session</a:t>
            </a:r>
          </a:p>
        </p:txBody>
      </p:sp>
      <p:sp>
        <p:nvSpPr>
          <p:cNvPr id="12" name="Rectangle 41">
            <a:extLst>
              <a:ext uri="{FF2B5EF4-FFF2-40B4-BE49-F238E27FC236}">
                <a16:creationId xmlns:a16="http://schemas.microsoft.com/office/drawing/2014/main" xmlns="" id="{7EC40B5A-BD2C-4DC3-878F-59CC210677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2" y="6287837"/>
            <a:ext cx="2507597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6B</a:t>
            </a:r>
          </a:p>
        </p:txBody>
      </p:sp>
    </p:spTree>
    <p:extLst>
      <p:ext uri="{BB962C8B-B14F-4D97-AF65-F5344CB8AC3E}">
        <p14:creationId xmlns:p14="http://schemas.microsoft.com/office/powerpoint/2010/main" val="35914497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xmlns="" id="{5568455B-8546-4703-92E5-796DEA75E084}"/>
              </a:ext>
            </a:extLst>
          </p:cNvPr>
          <p:cNvGrpSpPr/>
          <p:nvPr/>
        </p:nvGrpSpPr>
        <p:grpSpPr>
          <a:xfrm>
            <a:off x="1304251" y="1310326"/>
            <a:ext cx="6102864" cy="3960258"/>
            <a:chOff x="983736" y="914401"/>
            <a:chExt cx="6102864" cy="3960258"/>
          </a:xfrm>
        </p:grpSpPr>
        <p:graphicFrame>
          <p:nvGraphicFramePr>
            <p:cNvPr id="2" name="グラフ 1">
              <a:extLst>
                <a:ext uri="{FF2B5EF4-FFF2-40B4-BE49-F238E27FC236}">
                  <a16:creationId xmlns:a16="http://schemas.microsoft.com/office/drawing/2014/main" xmlns="" id="{B05E8855-F1FD-4406-8816-D8EB0FB34D0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51887357"/>
                </p:ext>
              </p:extLst>
            </p:nvPr>
          </p:nvGraphicFramePr>
          <p:xfrm>
            <a:off x="983736" y="914401"/>
            <a:ext cx="6102864" cy="39602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cxnSp>
          <p:nvCxnSpPr>
            <p:cNvPr id="3" name="直線コネクタ 2">
              <a:extLst>
                <a:ext uri="{FF2B5EF4-FFF2-40B4-BE49-F238E27FC236}">
                  <a16:creationId xmlns:a16="http://schemas.microsoft.com/office/drawing/2014/main" xmlns="" id="{58B7FF25-FD0D-4D4E-A685-E9E2FD498F73}"/>
                </a:ext>
              </a:extLst>
            </p:cNvPr>
            <p:cNvCxnSpPr/>
            <p:nvPr/>
          </p:nvCxnSpPr>
          <p:spPr>
            <a:xfrm>
              <a:off x="1644166" y="4369774"/>
              <a:ext cx="524021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" name="直線コネクタ 3">
              <a:extLst>
                <a:ext uri="{FF2B5EF4-FFF2-40B4-BE49-F238E27FC236}">
                  <a16:creationId xmlns:a16="http://schemas.microsoft.com/office/drawing/2014/main" xmlns="" id="{6B7308AA-D67B-440A-A200-1148E0F26B03}"/>
                </a:ext>
              </a:extLst>
            </p:cNvPr>
            <p:cNvCxnSpPr>
              <a:cxnSpLocks/>
            </p:cNvCxnSpPr>
            <p:nvPr/>
          </p:nvCxnSpPr>
          <p:spPr>
            <a:xfrm>
              <a:off x="1556240" y="1477105"/>
              <a:ext cx="0" cy="2892669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" name="グループ化 4">
              <a:extLst>
                <a:ext uri="{FF2B5EF4-FFF2-40B4-BE49-F238E27FC236}">
                  <a16:creationId xmlns:a16="http://schemas.microsoft.com/office/drawing/2014/main" xmlns="" id="{3EA57853-4648-47C7-AD1B-B6C9D8A1A0BD}"/>
                </a:ext>
              </a:extLst>
            </p:cNvPr>
            <p:cNvGrpSpPr/>
            <p:nvPr/>
          </p:nvGrpSpPr>
          <p:grpSpPr>
            <a:xfrm rot="5400000">
              <a:off x="1500284" y="4131885"/>
              <a:ext cx="96718" cy="203219"/>
              <a:chOff x="5402012" y="1314145"/>
              <a:chExt cx="261761" cy="801983"/>
            </a:xfrm>
          </p:grpSpPr>
          <p:sp>
            <p:nvSpPr>
              <p:cNvPr id="6" name="フリーフォーム 76">
                <a:extLst>
                  <a:ext uri="{FF2B5EF4-FFF2-40B4-BE49-F238E27FC236}">
                    <a16:creationId xmlns:a16="http://schemas.microsoft.com/office/drawing/2014/main" xmlns="" id="{8D616EEA-39D4-48FC-9802-854193636561}"/>
                  </a:ext>
                </a:extLst>
              </p:cNvPr>
              <p:cNvSpPr/>
              <p:nvPr/>
            </p:nvSpPr>
            <p:spPr>
              <a:xfrm rot="16200000">
                <a:off x="5061143" y="1665897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  <p:sp>
            <p:nvSpPr>
              <p:cNvPr id="7" name="フリーフォーム 77">
                <a:extLst>
                  <a:ext uri="{FF2B5EF4-FFF2-40B4-BE49-F238E27FC236}">
                    <a16:creationId xmlns:a16="http://schemas.microsoft.com/office/drawing/2014/main" xmlns="" id="{519014DD-1FA8-44B2-BA33-FBB574820739}"/>
                  </a:ext>
                </a:extLst>
              </p:cNvPr>
              <p:cNvSpPr/>
              <p:nvPr/>
            </p:nvSpPr>
            <p:spPr>
              <a:xfrm rot="16200000">
                <a:off x="5213543" y="1655014"/>
                <a:ext cx="791100" cy="109361"/>
              </a:xfrm>
              <a:custGeom>
                <a:avLst/>
                <a:gdLst>
                  <a:gd name="connsiteX0" fmla="*/ 0 w 1028700"/>
                  <a:gd name="connsiteY0" fmla="*/ 206125 h 252330"/>
                  <a:gd name="connsiteX1" fmla="*/ 308610 w 1028700"/>
                  <a:gd name="connsiteY1" fmla="*/ 385 h 252330"/>
                  <a:gd name="connsiteX2" fmla="*/ 617220 w 1028700"/>
                  <a:gd name="connsiteY2" fmla="*/ 251845 h 252330"/>
                  <a:gd name="connsiteX3" fmla="*/ 1028700 w 1028700"/>
                  <a:gd name="connsiteY3" fmla="*/ 68965 h 252330"/>
                  <a:gd name="connsiteX4" fmla="*/ 1028700 w 1028700"/>
                  <a:gd name="connsiteY4" fmla="*/ 68965 h 25233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1028700" h="252330">
                    <a:moveTo>
                      <a:pt x="0" y="206125"/>
                    </a:moveTo>
                    <a:cubicBezTo>
                      <a:pt x="102870" y="99445"/>
                      <a:pt x="205740" y="-7235"/>
                      <a:pt x="308610" y="385"/>
                    </a:cubicBezTo>
                    <a:cubicBezTo>
                      <a:pt x="411480" y="8005"/>
                      <a:pt x="497205" y="240415"/>
                      <a:pt x="617220" y="251845"/>
                    </a:cubicBezTo>
                    <a:cubicBezTo>
                      <a:pt x="737235" y="263275"/>
                      <a:pt x="1028700" y="68965"/>
                      <a:pt x="1028700" y="68965"/>
                    </a:cubicBezTo>
                    <a:lnTo>
                      <a:pt x="1028700" y="68965"/>
                    </a:lnTo>
                  </a:path>
                </a:pathLst>
              </a:custGeom>
              <a:noFill/>
              <a:ln w="9525" cap="flat" cmpd="sng" algn="ctr">
                <a:solidFill>
                  <a:schemeClr val="tx1"/>
                </a:solidFill>
                <a:prstDash val="solid"/>
                <a:miter lim="800000"/>
              </a:ln>
              <a:effectLst/>
            </p:spPr>
            <p:txBody>
              <a:bodyPr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1" lang="ja-JP" altLang="en-US" sz="1400" b="0" i="0" u="none" strike="noStrike" kern="0" cap="none" spc="0" normalizeH="0" baseline="0" noProof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/>
                  <a:ea typeface="ＭＳ Ｐゴシック" panose="020B0600070205080204" pitchFamily="50" charset="-128"/>
                  <a:cs typeface="+mn-cs"/>
                </a:endParaRPr>
              </a:p>
            </p:txBody>
          </p:sp>
        </p:grp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xmlns="" id="{0FBA4F05-AD89-4958-AB0F-17E832256452}"/>
                </a:ext>
              </a:extLst>
            </p:cNvPr>
            <p:cNvSpPr/>
            <p:nvPr/>
          </p:nvSpPr>
          <p:spPr>
            <a:xfrm>
              <a:off x="1083735" y="4286844"/>
              <a:ext cx="434837" cy="2399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11" name="Rectangle 41">
            <a:extLst>
              <a:ext uri="{FF2B5EF4-FFF2-40B4-BE49-F238E27FC236}">
                <a16:creationId xmlns:a16="http://schemas.microsoft.com/office/drawing/2014/main" xmlns="" id="{56BD759F-C440-465E-A2B3-3FE0941060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893532" y="5056112"/>
            <a:ext cx="1654264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b="1" dirty="0">
                <a:solidFill>
                  <a:srgbClr val="000000"/>
                </a:solidFill>
              </a:rPr>
              <a:t>HAL</a:t>
            </a:r>
            <a:r>
              <a:rPr lang="ja-JP" altLang="en-US" b="1" dirty="0">
                <a:solidFill>
                  <a:srgbClr val="000000"/>
                </a:solidFill>
              </a:rPr>
              <a:t> </a:t>
            </a:r>
            <a:r>
              <a:rPr lang="en-US" altLang="ja-JP" b="1" dirty="0">
                <a:solidFill>
                  <a:srgbClr val="000000"/>
                </a:solidFill>
              </a:rPr>
              <a:t>session</a:t>
            </a:r>
          </a:p>
        </p:txBody>
      </p:sp>
      <p:sp>
        <p:nvSpPr>
          <p:cNvPr id="12" name="Rectangle 41">
            <a:extLst>
              <a:ext uri="{FF2B5EF4-FFF2-40B4-BE49-F238E27FC236}">
                <a16:creationId xmlns:a16="http://schemas.microsoft.com/office/drawing/2014/main" xmlns="" id="{CCCA4F0E-5019-4D07-B57B-7CE4D2EFC8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6672" y="6287837"/>
            <a:ext cx="2507597" cy="3606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folHlink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anchor="ctr"/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2400" b="1" dirty="0">
                <a:solidFill>
                  <a:srgbClr val="000000"/>
                </a:solidFill>
                <a:latin typeface="Times New Roman" charset="0"/>
                <a:ea typeface="ＭＳ ゴシック" pitchFamily="49" charset="-128"/>
              </a:rPr>
              <a:t>Additional file 6C</a:t>
            </a:r>
          </a:p>
        </p:txBody>
      </p:sp>
    </p:spTree>
    <p:extLst>
      <p:ext uri="{BB962C8B-B14F-4D97-AF65-F5344CB8AC3E}">
        <p14:creationId xmlns:p14="http://schemas.microsoft.com/office/powerpoint/2010/main" val="2366543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4472C4"/>
    </a:accent1>
    <a:accent2>
      <a:srgbClr val="ED7D31"/>
    </a:accent2>
    <a:accent3>
      <a:srgbClr val="A5A5A5"/>
    </a:accent3>
    <a:accent4>
      <a:srgbClr val="FFC000"/>
    </a:accent4>
    <a:accent5>
      <a:srgbClr val="5B9BD5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11</TotalTime>
  <Words>29</Words>
  <Application>Microsoft Office PowerPoint</Application>
  <PresentationFormat>On-screen Show (4:3)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2" baseType="lpstr">
      <vt:lpstr>ＭＳ ゴシック</vt:lpstr>
      <vt:lpstr>ＭＳ Ｐ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小倉登美子</dc:title>
  <dc:creator>Windows ユーザー</dc:creator>
  <cp:lastModifiedBy>Pon Abirami A.</cp:lastModifiedBy>
  <cp:revision>223</cp:revision>
  <cp:lastPrinted>2021-09-27T09:12:48Z</cp:lastPrinted>
  <dcterms:created xsi:type="dcterms:W3CDTF">2019-06-13T02:17:03Z</dcterms:created>
  <dcterms:modified xsi:type="dcterms:W3CDTF">2022-02-23T03:15:01Z</dcterms:modified>
</cp:coreProperties>
</file>